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DD2B9-9FC2-4613-BDF3-3B0A610DF1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64000-F577-4CE1-8CF6-5E6FCA1B18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5BA2B-7A17-4BD0-9B6C-C9C3FB3C5C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DB26A-7D22-47D0-960D-D1A2D8519F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AD26B-F5FF-4CEE-878F-F153F6F988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8EFA6-2A84-4E49-A9ED-AE1FCF8C16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7C6B7-3CCF-4885-AF6A-693ABDC2B3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318D6-B8A1-4959-B0B4-D26CA530CC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06D15-859A-4ED7-82D0-C471F867AD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7E305-283A-48F2-BFEE-66FBD47272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450F4-0F77-4E4E-89F1-DF76120CF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66F739-4D13-4F29-ACE2-DA5CD6E894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4E9EA3-905D-4D78-A856-6B3B4A77ACC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609480" y="533520"/>
            <a:ext cx="8077320" cy="106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able S2: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Quantitative segregation of planktonic and dispersed cells adhered to endothelial cells based on their morphological differentiation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upon adhe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219320" y="2484360"/>
          <a:ext cx="6324480" cy="1724040"/>
        </p:xfrm>
        <a:graphic>
          <a:graphicData uri="http://schemas.openxmlformats.org/drawingml/2006/table">
            <a:tbl>
              <a:tblPr/>
              <a:tblGrid>
                <a:gridCol w="2509560"/>
                <a:gridCol w="2108520"/>
                <a:gridCol w="1706400"/>
              </a:tblGrid>
              <a:tr h="457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iofilm Dispers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lanktonic (37</a:t>
                      </a:r>
                      <a:r>
                        <a:rPr b="1" lang="en-US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111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verage adhered cells (10 field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4</a:t>
                      </a: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Arial"/>
                        </a:rPr>
                        <a:t>+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9</a:t>
                      </a: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Arial"/>
                        </a:rPr>
                        <a:t>+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1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lastospores (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5</a:t>
                      </a: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Arial"/>
                        </a:rPr>
                        <a:t>+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.7</a:t>
                      </a: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Arial"/>
                        </a:rPr>
                        <a:t>+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4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rm tubes (%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0.5</a:t>
                      </a: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Arial"/>
                        </a:rPr>
                        <a:t>+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4.2</a:t>
                      </a: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Arial"/>
                        </a:rPr>
                        <a:t>+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6T19:57:21Z</dcterms:created>
  <dc:creator>Prius Inc</dc:creator>
  <dc:description/>
  <dc:language>en-US</dc:language>
  <cp:lastModifiedBy>Prius Inc</cp:lastModifiedBy>
  <dcterms:modified xsi:type="dcterms:W3CDTF">2009-11-06T19:59:17Z</dcterms:modified>
  <cp:revision>1</cp:revision>
  <dc:subject/>
  <dc:title>Slide 1</dc:title>
</cp:coreProperties>
</file>